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348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F09F24AA-F00F-46EC-85F0-0A7D788A31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xmlns="" id="{3EA8B8FA-0AFF-4E2C-9880-A6C85AF447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18444360-A8DA-44D8-8BA8-573282E1B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0E3A086A-EA83-492A-BF0D-A3D78B866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7B602F18-EB3E-47C0-B58B-F96687073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456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2CA859BB-8CE6-4820-AFAF-DFD8C616BB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44E1D115-6209-408D-827D-568B635CB8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EFC8D169-0B86-4425-9D59-55A411637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00F6C798-1D7A-4875-B1CC-70BDF6958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F13FB0D2-0C18-4618-9CD3-73F2FAC71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1840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xmlns="" id="{040ACA52-557A-450C-AEEB-7EC32D8D95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F2F5BF38-E1ED-4BA6-84B2-0005534104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7F3F1511-0DD9-4FEF-BD1F-296470F8E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243F1125-ED16-4599-BA53-F86C7BEAF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E7F08A06-509E-421A-86E1-22EDE59C1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2213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9F40315-8110-4440-9E1D-3D83014BF8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3192DF16-5D02-4853-99BD-BB45E1CA98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BB6ECFFF-40F5-4F54-BBBC-A9763301D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E94D8A50-EE42-4195-B343-D19435787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FD6B1712-AFA2-46B7-B1F4-BA1B931541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8265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5F478CEC-AA38-4BC0-A0B3-DC2C385F8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ADE95F53-AD43-4046-B45E-3F3806334C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BD2A2A88-4E8F-45E8-BFF1-F1521A286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43E10E34-0741-4024-93D6-406929444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373FF448-F79F-4141-876D-2FEAB99B8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372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CEAA6A25-4D55-4F65-8795-22F4022F80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84529050-2D82-4017-A4D5-91DA43B85E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A4421BFD-1C98-45B5-8400-7A47A11C3E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74F895A3-0BBA-4BAF-8D07-7AB7F7053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03A5DC99-8F9C-4DC9-AF84-A91D2B3D2C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618E663F-4FC6-48CD-9CE8-574115887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4385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8CF4391F-EBA7-47EC-8C7F-406E0CCD78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AAE2FFE4-5BA4-483D-BE4F-7981198F7D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165B6116-413E-466F-86F2-69FA729C58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xmlns="" id="{380A0A7A-4BBE-4BBC-892E-1D43235D22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xmlns="" id="{60CECC7D-8669-4FCE-B73F-2E36BD19A7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xmlns="" id="{A9D3D5FD-5BA2-461D-B4B1-09B4560D7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xmlns="" id="{72378D9D-062B-425D-A676-E7BDE96F9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xmlns="" id="{545BB178-4E0F-4114-B5C7-E3353D343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3062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F6055326-5F2A-46BA-B792-C51306A189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xmlns="" id="{67C001CA-33F4-4D25-8545-13AA9FC15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xmlns="" id="{06A8FD3F-C86F-43EE-974B-753DA20D7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xmlns="" id="{94BED168-EB26-4D6D-8241-CA8BACC97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7564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xmlns="" id="{23BDD770-3152-4AF4-BDB1-2B98E7FB4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xmlns="" id="{F51548B2-5228-42C2-B77D-76BCB394B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xmlns="" id="{E94E322C-5951-420E-A704-FDC4BF1AF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0114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5D06BEFA-0E3E-4431-8234-EEAD0E2BEA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14799BA5-9727-4EE8-A2B9-D151E9E11C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88606C55-C05B-4F89-902D-942D7F9817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8069992C-7D9A-4232-8B22-1D1F11310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F2C383D9-842B-4F59-B6F5-C8897501D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17DD7EC0-9681-42BC-A13E-8D9F19D84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7115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2E6C549F-AAE5-4D4B-9AE0-2BD50FAA97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xmlns="" id="{3B56C6D1-52A3-4A81-9056-7A2261C03A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927C938B-E349-466C-9564-E2BDF520F1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69F55B8C-E745-4C34-96FD-720A56426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058018C7-F061-4CC6-BA99-46F6FAC5D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C017740A-2D89-473E-8F5D-54E1883BB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998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xmlns="" id="{39010FB6-A534-4D0E-A562-792D35829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00BA78F8-086C-4302-AE14-3B57C97D90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90F4923F-5EF4-4237-B34A-DACB3276CF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3C5F-D1DD-4C97-9EF8-FF01973AA7A9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A52F63B4-5935-4F2A-A712-9F9C0B1DC4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270C9D71-1182-4C1F-94FD-032C08BB73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0392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C0197A19-4333-4C35-AB55-53A40AFF2560}"/>
              </a:ext>
            </a:extLst>
          </p:cNvPr>
          <p:cNvSpPr txBox="1"/>
          <p:nvPr/>
        </p:nvSpPr>
        <p:spPr>
          <a:xfrm>
            <a:off x="82759" y="243291"/>
            <a:ext cx="7002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>
                <a:latin typeface="Arial" panose="020B0604020202020204" pitchFamily="34" charset="0"/>
                <a:cs typeface="Arial" panose="020B0604020202020204" pitchFamily="34" charset="0"/>
              </a:rPr>
              <a:t>S3 Fig. Raw blot images related to Fig 5. 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그룹 36">
            <a:extLst>
              <a:ext uri="{FF2B5EF4-FFF2-40B4-BE49-F238E27FC236}">
                <a16:creationId xmlns:a16="http://schemas.microsoft.com/office/drawing/2014/main" xmlns="" id="{4EF9BC1B-A193-40A4-9EF0-D8FDA65215D9}"/>
              </a:ext>
            </a:extLst>
          </p:cNvPr>
          <p:cNvGrpSpPr/>
          <p:nvPr/>
        </p:nvGrpSpPr>
        <p:grpSpPr>
          <a:xfrm>
            <a:off x="417139" y="1580342"/>
            <a:ext cx="3384557" cy="3234818"/>
            <a:chOff x="82759" y="1208899"/>
            <a:chExt cx="3384557" cy="3234818"/>
          </a:xfrm>
        </p:grpSpPr>
        <p:grpSp>
          <p:nvGrpSpPr>
            <p:cNvPr id="36" name="그룹 35">
              <a:extLst>
                <a:ext uri="{FF2B5EF4-FFF2-40B4-BE49-F238E27FC236}">
                  <a16:creationId xmlns:a16="http://schemas.microsoft.com/office/drawing/2014/main" xmlns="" id="{34A030F9-CAD9-4D32-8891-445E07F15A02}"/>
                </a:ext>
              </a:extLst>
            </p:cNvPr>
            <p:cNvGrpSpPr/>
            <p:nvPr/>
          </p:nvGrpSpPr>
          <p:grpSpPr>
            <a:xfrm>
              <a:off x="178672" y="1585430"/>
              <a:ext cx="3288644" cy="2858287"/>
              <a:chOff x="513872" y="1663051"/>
              <a:chExt cx="3288644" cy="2858287"/>
            </a:xfrm>
          </p:grpSpPr>
          <p:pic>
            <p:nvPicPr>
              <p:cNvPr id="16" name="그림 15">
                <a:extLst>
                  <a:ext uri="{FF2B5EF4-FFF2-40B4-BE49-F238E27FC236}">
                    <a16:creationId xmlns:a16="http://schemas.microsoft.com/office/drawing/2014/main" xmlns="" id="{56E32E1F-4D35-4FCD-ACD3-E0E309B09A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60710" y="2468483"/>
                <a:ext cx="1595264" cy="20528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7" name="직사각형 16">
                <a:extLst>
                  <a:ext uri="{FF2B5EF4-FFF2-40B4-BE49-F238E27FC236}">
                    <a16:creationId xmlns:a16="http://schemas.microsoft.com/office/drawing/2014/main" xmlns="" id="{E6BBA065-9C60-4E62-A8D6-1234D732C6F1}"/>
                  </a:ext>
                </a:extLst>
              </p:cNvPr>
              <p:cNvSpPr/>
              <p:nvPr/>
            </p:nvSpPr>
            <p:spPr>
              <a:xfrm>
                <a:off x="1060710" y="3625875"/>
                <a:ext cx="1595264" cy="411158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n w="5715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xmlns="" id="{E0569DDD-DD5E-4477-893D-040C87D8D7F0}"/>
                  </a:ext>
                </a:extLst>
              </p:cNvPr>
              <p:cNvSpPr txBox="1"/>
              <p:nvPr/>
            </p:nvSpPr>
            <p:spPr>
              <a:xfrm>
                <a:off x="2645099" y="3730097"/>
                <a:ext cx="11574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yrosinase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5" name="그룹 84">
                <a:extLst>
                  <a:ext uri="{FF2B5EF4-FFF2-40B4-BE49-F238E27FC236}">
                    <a16:creationId xmlns:a16="http://schemas.microsoft.com/office/drawing/2014/main" xmlns="" id="{DA052A63-1AB7-4DC1-8974-1C5B5CACC6AC}"/>
                  </a:ext>
                </a:extLst>
              </p:cNvPr>
              <p:cNvGrpSpPr/>
              <p:nvPr/>
            </p:nvGrpSpPr>
            <p:grpSpPr>
              <a:xfrm>
                <a:off x="513872" y="1663051"/>
                <a:ext cx="2129345" cy="810913"/>
                <a:chOff x="122955" y="924336"/>
                <a:chExt cx="2129345" cy="810913"/>
              </a:xfrm>
            </p:grpSpPr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xmlns="" id="{BDCC4983-5385-4A09-B8FC-37D2B5701538}"/>
                    </a:ext>
                  </a:extLst>
                </p:cNvPr>
                <p:cNvSpPr txBox="1"/>
                <p:nvPr/>
              </p:nvSpPr>
              <p:spPr>
                <a:xfrm>
                  <a:off x="890114" y="924336"/>
                  <a:ext cx="828768" cy="2708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rambled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xmlns="" id="{4B12C791-58BB-46FF-A9A3-647DE1298D1A}"/>
                    </a:ext>
                  </a:extLst>
                </p:cNvPr>
                <p:cNvSpPr txBox="1"/>
                <p:nvPr/>
              </p:nvSpPr>
              <p:spPr>
                <a:xfrm>
                  <a:off x="1809333" y="924336"/>
                  <a:ext cx="442967" cy="4401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g5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직사각형 87">
                  <a:extLst>
                    <a:ext uri="{FF2B5EF4-FFF2-40B4-BE49-F238E27FC236}">
                      <a16:creationId xmlns:a16="http://schemas.microsoft.com/office/drawing/2014/main" xmlns="" id="{8D7E59EC-E63B-4265-8FC9-57C4D0036FE4}"/>
                    </a:ext>
                  </a:extLst>
                </p:cNvPr>
                <p:cNvSpPr/>
                <p:nvPr/>
              </p:nvSpPr>
              <p:spPr>
                <a:xfrm>
                  <a:off x="832504" y="1193623"/>
                  <a:ext cx="1341635" cy="270843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dist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+++</a:t>
                  </a:r>
                </a:p>
              </p:txBody>
            </p:sp>
            <p:sp>
              <p:nvSpPr>
                <p:cNvPr id="89" name="직사각형 88">
                  <a:extLst>
                    <a:ext uri="{FF2B5EF4-FFF2-40B4-BE49-F238E27FC236}">
                      <a16:creationId xmlns:a16="http://schemas.microsoft.com/office/drawing/2014/main" xmlns="" id="{F72E32B9-591D-4181-A2EC-E03F6E2AF196}"/>
                    </a:ext>
                  </a:extLst>
                </p:cNvPr>
                <p:cNvSpPr/>
                <p:nvPr/>
              </p:nvSpPr>
              <p:spPr>
                <a:xfrm>
                  <a:off x="832504" y="1465787"/>
                  <a:ext cx="1341635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dist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-++</a:t>
                  </a:r>
                </a:p>
              </p:txBody>
            </p:sp>
            <p:sp>
              <p:nvSpPr>
                <p:cNvPr id="90" name="직사각형 89">
                  <a:extLst>
                    <a:ext uri="{FF2B5EF4-FFF2-40B4-BE49-F238E27FC236}">
                      <a16:creationId xmlns:a16="http://schemas.microsoft.com/office/drawing/2014/main" xmlns="" id="{91D38E3B-7CAC-4814-817A-5CE5626A4BE3}"/>
                    </a:ext>
                  </a:extLst>
                </p:cNvPr>
                <p:cNvSpPr/>
                <p:nvPr/>
              </p:nvSpPr>
              <p:spPr>
                <a:xfrm>
                  <a:off x="122955" y="1464406"/>
                  <a:ext cx="689612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ko-KR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elasolv</a:t>
                  </a:r>
                  <a:endPara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직사각형 90">
                  <a:extLst>
                    <a:ext uri="{FF2B5EF4-FFF2-40B4-BE49-F238E27FC236}">
                      <a16:creationId xmlns:a16="http://schemas.microsoft.com/office/drawing/2014/main" xmlns="" id="{590264D0-76FF-4C1B-B33D-E490FE704EA5}"/>
                    </a:ext>
                  </a:extLst>
                </p:cNvPr>
                <p:cNvSpPr/>
                <p:nvPr/>
              </p:nvSpPr>
              <p:spPr>
                <a:xfrm>
                  <a:off x="225547" y="1213122"/>
                  <a:ext cx="587020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l-GR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-</a:t>
                  </a:r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SH</a:t>
                  </a:r>
                </a:p>
              </p:txBody>
            </p:sp>
            <p:sp>
              <p:nvSpPr>
                <p:cNvPr id="92" name="직사각형 91">
                  <a:extLst>
                    <a:ext uri="{FF2B5EF4-FFF2-40B4-BE49-F238E27FC236}">
                      <a16:creationId xmlns:a16="http://schemas.microsoft.com/office/drawing/2014/main" xmlns="" id="{55200551-E34C-4411-B25C-65FD23BD676F}"/>
                    </a:ext>
                  </a:extLst>
                </p:cNvPr>
                <p:cNvSpPr/>
                <p:nvPr/>
              </p:nvSpPr>
              <p:spPr>
                <a:xfrm>
                  <a:off x="244082" y="985749"/>
                  <a:ext cx="548548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RNA</a:t>
                  </a:r>
                </a:p>
              </p:txBody>
            </p:sp>
            <p:cxnSp>
              <p:nvCxnSpPr>
                <p:cNvPr id="93" name="직선 연결선 92">
                  <a:extLst>
                    <a:ext uri="{FF2B5EF4-FFF2-40B4-BE49-F238E27FC236}">
                      <a16:creationId xmlns:a16="http://schemas.microsoft.com/office/drawing/2014/main" xmlns="" id="{B5521E30-7206-46C5-A465-D4C97626F75B}"/>
                    </a:ext>
                  </a:extLst>
                </p:cNvPr>
                <p:cNvCxnSpPr/>
                <p:nvPr/>
              </p:nvCxnSpPr>
              <p:spPr>
                <a:xfrm>
                  <a:off x="901637" y="1193623"/>
                  <a:ext cx="81724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직선 연결선 93">
                  <a:extLst>
                    <a:ext uri="{FF2B5EF4-FFF2-40B4-BE49-F238E27FC236}">
                      <a16:creationId xmlns:a16="http://schemas.microsoft.com/office/drawing/2014/main" xmlns="" id="{4548C955-ED49-4A3D-ACFE-F96581D5AA4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98074" y="1193623"/>
                  <a:ext cx="275047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xmlns="" id="{103954E4-E00D-464B-85FF-42A54E85338F}"/>
                </a:ext>
              </a:extLst>
            </p:cNvPr>
            <p:cNvSpPr txBox="1"/>
            <p:nvPr/>
          </p:nvSpPr>
          <p:spPr>
            <a:xfrm>
              <a:off x="82759" y="120889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그룹 37">
            <a:extLst>
              <a:ext uri="{FF2B5EF4-FFF2-40B4-BE49-F238E27FC236}">
                <a16:creationId xmlns:a16="http://schemas.microsoft.com/office/drawing/2014/main" xmlns="" id="{8D385ACC-FD10-4CCE-B07A-A982A3E1028A}"/>
              </a:ext>
            </a:extLst>
          </p:cNvPr>
          <p:cNvGrpSpPr/>
          <p:nvPr/>
        </p:nvGrpSpPr>
        <p:grpSpPr>
          <a:xfrm>
            <a:off x="3142177" y="1580342"/>
            <a:ext cx="3432096" cy="3813976"/>
            <a:chOff x="3154215" y="1208899"/>
            <a:chExt cx="3432096" cy="3813976"/>
          </a:xfrm>
        </p:grpSpPr>
        <p:grpSp>
          <p:nvGrpSpPr>
            <p:cNvPr id="35" name="그룹 34">
              <a:extLst>
                <a:ext uri="{FF2B5EF4-FFF2-40B4-BE49-F238E27FC236}">
                  <a16:creationId xmlns:a16="http://schemas.microsoft.com/office/drawing/2014/main" xmlns="" id="{BD38E310-8722-41E2-BB7B-AEED428366AF}"/>
                </a:ext>
              </a:extLst>
            </p:cNvPr>
            <p:cNvGrpSpPr/>
            <p:nvPr/>
          </p:nvGrpSpPr>
          <p:grpSpPr>
            <a:xfrm>
              <a:off x="3407104" y="1585430"/>
              <a:ext cx="3179207" cy="3437445"/>
              <a:chOff x="3462940" y="1672343"/>
              <a:chExt cx="3179207" cy="3437445"/>
            </a:xfrm>
          </p:grpSpPr>
          <p:pic>
            <p:nvPicPr>
              <p:cNvPr id="3" name="그림 2" descr="모니터, 원격, 제어, 텔레비전이(가) 표시된 사진&#10;&#10;자동 생성된 설명">
                <a:extLst>
                  <a:ext uri="{FF2B5EF4-FFF2-40B4-BE49-F238E27FC236}">
                    <a16:creationId xmlns:a16="http://schemas.microsoft.com/office/drawing/2014/main" xmlns="" id="{C1BC18FD-ED2F-42AF-944D-1EE819EA69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98854" y="2468483"/>
                <a:ext cx="1584400" cy="264130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xmlns="" id="{A6776EC0-A509-450B-9E24-C8FDB9D2211F}"/>
                  </a:ext>
                </a:extLst>
              </p:cNvPr>
              <p:cNvSpPr txBox="1"/>
              <p:nvPr/>
            </p:nvSpPr>
            <p:spPr>
              <a:xfrm>
                <a:off x="5716719" y="3947947"/>
                <a:ext cx="925428" cy="24622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tg5-Atg1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직사각형 23">
                <a:extLst>
                  <a:ext uri="{FF2B5EF4-FFF2-40B4-BE49-F238E27FC236}">
                    <a16:creationId xmlns:a16="http://schemas.microsoft.com/office/drawing/2014/main" xmlns="" id="{F340510F-3F74-4A9B-A684-3713BE6453C4}"/>
                  </a:ext>
                </a:extLst>
              </p:cNvPr>
              <p:cNvSpPr/>
              <p:nvPr/>
            </p:nvSpPr>
            <p:spPr>
              <a:xfrm>
                <a:off x="4096425" y="3911761"/>
                <a:ext cx="1595264" cy="331711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n w="57150">
                    <a:solidFill>
                      <a:schemeClr val="tx1"/>
                    </a:solidFill>
                  </a:ln>
                </a:endParaRPr>
              </a:p>
            </p:txBody>
          </p:sp>
          <p:grpSp>
            <p:nvGrpSpPr>
              <p:cNvPr id="95" name="그룹 94">
                <a:extLst>
                  <a:ext uri="{FF2B5EF4-FFF2-40B4-BE49-F238E27FC236}">
                    <a16:creationId xmlns:a16="http://schemas.microsoft.com/office/drawing/2014/main" xmlns="" id="{6907D0D5-B905-41FF-83D4-2C03CD84776E}"/>
                  </a:ext>
                </a:extLst>
              </p:cNvPr>
              <p:cNvGrpSpPr/>
              <p:nvPr/>
            </p:nvGrpSpPr>
            <p:grpSpPr>
              <a:xfrm>
                <a:off x="3462940" y="1672343"/>
                <a:ext cx="2129345" cy="810913"/>
                <a:chOff x="122955" y="924336"/>
                <a:chExt cx="2129345" cy="810913"/>
              </a:xfrm>
            </p:grpSpPr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xmlns="" id="{5D3824BC-CA4E-480D-9D9A-D6969AECE230}"/>
                    </a:ext>
                  </a:extLst>
                </p:cNvPr>
                <p:cNvSpPr txBox="1"/>
                <p:nvPr/>
              </p:nvSpPr>
              <p:spPr>
                <a:xfrm>
                  <a:off x="890114" y="924336"/>
                  <a:ext cx="828768" cy="2708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rambled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xmlns="" id="{FB2E053A-451B-47FA-8BC0-D6E453117548}"/>
                    </a:ext>
                  </a:extLst>
                </p:cNvPr>
                <p:cNvSpPr txBox="1"/>
                <p:nvPr/>
              </p:nvSpPr>
              <p:spPr>
                <a:xfrm>
                  <a:off x="1809333" y="924336"/>
                  <a:ext cx="442967" cy="4401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g5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직사각형 97">
                  <a:extLst>
                    <a:ext uri="{FF2B5EF4-FFF2-40B4-BE49-F238E27FC236}">
                      <a16:creationId xmlns:a16="http://schemas.microsoft.com/office/drawing/2014/main" xmlns="" id="{6263B67D-FFE5-4965-A070-02C764FE7390}"/>
                    </a:ext>
                  </a:extLst>
                </p:cNvPr>
                <p:cNvSpPr/>
                <p:nvPr/>
              </p:nvSpPr>
              <p:spPr>
                <a:xfrm>
                  <a:off x="832504" y="1193623"/>
                  <a:ext cx="1341635" cy="270843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dist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+++</a:t>
                  </a:r>
                </a:p>
              </p:txBody>
            </p:sp>
            <p:sp>
              <p:nvSpPr>
                <p:cNvPr id="99" name="직사각형 98">
                  <a:extLst>
                    <a:ext uri="{FF2B5EF4-FFF2-40B4-BE49-F238E27FC236}">
                      <a16:creationId xmlns:a16="http://schemas.microsoft.com/office/drawing/2014/main" xmlns="" id="{8A8F34BE-AB56-41D6-816C-7E63C35CFFC4}"/>
                    </a:ext>
                  </a:extLst>
                </p:cNvPr>
                <p:cNvSpPr/>
                <p:nvPr/>
              </p:nvSpPr>
              <p:spPr>
                <a:xfrm>
                  <a:off x="832504" y="1465787"/>
                  <a:ext cx="1341635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dist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-++</a:t>
                  </a:r>
                </a:p>
              </p:txBody>
            </p:sp>
            <p:sp>
              <p:nvSpPr>
                <p:cNvPr id="100" name="직사각형 99">
                  <a:extLst>
                    <a:ext uri="{FF2B5EF4-FFF2-40B4-BE49-F238E27FC236}">
                      <a16:creationId xmlns:a16="http://schemas.microsoft.com/office/drawing/2014/main" xmlns="" id="{40D974C9-F804-4058-BCEB-48B9BBBD1A63}"/>
                    </a:ext>
                  </a:extLst>
                </p:cNvPr>
                <p:cNvSpPr/>
                <p:nvPr/>
              </p:nvSpPr>
              <p:spPr>
                <a:xfrm>
                  <a:off x="122955" y="1464406"/>
                  <a:ext cx="689612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ko-KR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elasolv</a:t>
                  </a:r>
                  <a:endPara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직사각형 100">
                  <a:extLst>
                    <a:ext uri="{FF2B5EF4-FFF2-40B4-BE49-F238E27FC236}">
                      <a16:creationId xmlns:a16="http://schemas.microsoft.com/office/drawing/2014/main" xmlns="" id="{E6A8409C-72A3-4515-B6E9-924E073477B8}"/>
                    </a:ext>
                  </a:extLst>
                </p:cNvPr>
                <p:cNvSpPr/>
                <p:nvPr/>
              </p:nvSpPr>
              <p:spPr>
                <a:xfrm>
                  <a:off x="225547" y="1213122"/>
                  <a:ext cx="587020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l-GR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-</a:t>
                  </a:r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SH</a:t>
                  </a:r>
                </a:p>
              </p:txBody>
            </p:sp>
            <p:sp>
              <p:nvSpPr>
                <p:cNvPr id="102" name="직사각형 101">
                  <a:extLst>
                    <a:ext uri="{FF2B5EF4-FFF2-40B4-BE49-F238E27FC236}">
                      <a16:creationId xmlns:a16="http://schemas.microsoft.com/office/drawing/2014/main" xmlns="" id="{CD2853CF-8A42-42C8-B1E4-2F445AF29689}"/>
                    </a:ext>
                  </a:extLst>
                </p:cNvPr>
                <p:cNvSpPr/>
                <p:nvPr/>
              </p:nvSpPr>
              <p:spPr>
                <a:xfrm>
                  <a:off x="244082" y="985749"/>
                  <a:ext cx="548548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RNA</a:t>
                  </a:r>
                </a:p>
              </p:txBody>
            </p:sp>
            <p:cxnSp>
              <p:nvCxnSpPr>
                <p:cNvPr id="103" name="직선 연결선 102">
                  <a:extLst>
                    <a:ext uri="{FF2B5EF4-FFF2-40B4-BE49-F238E27FC236}">
                      <a16:creationId xmlns:a16="http://schemas.microsoft.com/office/drawing/2014/main" xmlns="" id="{391A9ACE-16F6-4E81-8E07-406B287E9CD3}"/>
                    </a:ext>
                  </a:extLst>
                </p:cNvPr>
                <p:cNvCxnSpPr/>
                <p:nvPr/>
              </p:nvCxnSpPr>
              <p:spPr>
                <a:xfrm>
                  <a:off x="901637" y="1193623"/>
                  <a:ext cx="81724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직선 연결선 103">
                  <a:extLst>
                    <a:ext uri="{FF2B5EF4-FFF2-40B4-BE49-F238E27FC236}">
                      <a16:creationId xmlns:a16="http://schemas.microsoft.com/office/drawing/2014/main" xmlns="" id="{A3AA0CB4-5E85-498A-89E4-F66B783D3F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98074" y="1193623"/>
                  <a:ext cx="275047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xmlns="" id="{D570D32E-D0BF-41DD-8FE4-5C12A1E84D35}"/>
                </a:ext>
              </a:extLst>
            </p:cNvPr>
            <p:cNvSpPr txBox="1"/>
            <p:nvPr/>
          </p:nvSpPr>
          <p:spPr>
            <a:xfrm>
              <a:off x="3154215" y="120889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그룹 38">
            <a:extLst>
              <a:ext uri="{FF2B5EF4-FFF2-40B4-BE49-F238E27FC236}">
                <a16:creationId xmlns:a16="http://schemas.microsoft.com/office/drawing/2014/main" xmlns="" id="{E21C7F67-D974-403A-872A-9665602BE527}"/>
              </a:ext>
            </a:extLst>
          </p:cNvPr>
          <p:cNvGrpSpPr/>
          <p:nvPr/>
        </p:nvGrpSpPr>
        <p:grpSpPr>
          <a:xfrm>
            <a:off x="6159862" y="1580342"/>
            <a:ext cx="3076111" cy="2853951"/>
            <a:chOff x="6314181" y="1208899"/>
            <a:chExt cx="3076111" cy="2853951"/>
          </a:xfrm>
        </p:grpSpPr>
        <p:grpSp>
          <p:nvGrpSpPr>
            <p:cNvPr id="34" name="그룹 33">
              <a:extLst>
                <a:ext uri="{FF2B5EF4-FFF2-40B4-BE49-F238E27FC236}">
                  <a16:creationId xmlns:a16="http://schemas.microsoft.com/office/drawing/2014/main" xmlns="" id="{9CE0AED9-B65C-4A23-8105-B22FE783A60A}"/>
                </a:ext>
              </a:extLst>
            </p:cNvPr>
            <p:cNvGrpSpPr/>
            <p:nvPr/>
          </p:nvGrpSpPr>
          <p:grpSpPr>
            <a:xfrm>
              <a:off x="6526099" y="1585430"/>
              <a:ext cx="2864193" cy="2477420"/>
              <a:chOff x="6151069" y="1559613"/>
              <a:chExt cx="2864193" cy="2477420"/>
            </a:xfrm>
          </p:grpSpPr>
          <p:pic>
            <p:nvPicPr>
              <p:cNvPr id="7" name="그림 6">
                <a:extLst>
                  <a:ext uri="{FF2B5EF4-FFF2-40B4-BE49-F238E27FC236}">
                    <a16:creationId xmlns:a16="http://schemas.microsoft.com/office/drawing/2014/main" xmlns="" id="{2EFD015D-4358-4F38-BBAA-9CDAE72322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45627" y="2408744"/>
                <a:ext cx="1584400" cy="162828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xmlns="" id="{9D2A3C73-2D15-46E1-A59F-FFEF98C047FF}"/>
                  </a:ext>
                </a:extLst>
              </p:cNvPr>
              <p:cNvSpPr txBox="1"/>
              <p:nvPr/>
            </p:nvSpPr>
            <p:spPr>
              <a:xfrm>
                <a:off x="8328829" y="3468239"/>
                <a:ext cx="68643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C3 I</a:t>
                </a:r>
              </a:p>
            </p:txBody>
          </p:sp>
          <p:sp>
            <p:nvSpPr>
              <p:cNvPr id="22" name="직사각형 21">
                <a:extLst>
                  <a:ext uri="{FF2B5EF4-FFF2-40B4-BE49-F238E27FC236}">
                    <a16:creationId xmlns:a16="http://schemas.microsoft.com/office/drawing/2014/main" xmlns="" id="{76D2953E-B022-4A00-B49C-DCEB0837FA6F}"/>
                  </a:ext>
                </a:extLst>
              </p:cNvPr>
              <p:cNvSpPr/>
              <p:nvPr/>
            </p:nvSpPr>
            <p:spPr>
              <a:xfrm>
                <a:off x="8328830" y="3611095"/>
                <a:ext cx="548430" cy="2946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C3 II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직사각형 24">
                <a:extLst>
                  <a:ext uri="{FF2B5EF4-FFF2-40B4-BE49-F238E27FC236}">
                    <a16:creationId xmlns:a16="http://schemas.microsoft.com/office/drawing/2014/main" xmlns="" id="{5AE16E4F-3A13-4AC4-9233-8790E5C81E7F}"/>
                  </a:ext>
                </a:extLst>
              </p:cNvPr>
              <p:cNvSpPr/>
              <p:nvPr/>
            </p:nvSpPr>
            <p:spPr>
              <a:xfrm>
                <a:off x="6745746" y="3420927"/>
                <a:ext cx="1595264" cy="483252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n w="57150">
                    <a:solidFill>
                      <a:schemeClr val="tx1"/>
                    </a:solidFill>
                  </a:ln>
                </a:endParaRPr>
              </a:p>
            </p:txBody>
          </p:sp>
          <p:grpSp>
            <p:nvGrpSpPr>
              <p:cNvPr id="105" name="그룹 104">
                <a:extLst>
                  <a:ext uri="{FF2B5EF4-FFF2-40B4-BE49-F238E27FC236}">
                    <a16:creationId xmlns:a16="http://schemas.microsoft.com/office/drawing/2014/main" xmlns="" id="{E22064ED-B0E3-4E31-92D3-E378212E4E56}"/>
                  </a:ext>
                </a:extLst>
              </p:cNvPr>
              <p:cNvGrpSpPr/>
              <p:nvPr/>
            </p:nvGrpSpPr>
            <p:grpSpPr>
              <a:xfrm>
                <a:off x="6151069" y="1559613"/>
                <a:ext cx="2129345" cy="810913"/>
                <a:chOff x="122955" y="924336"/>
                <a:chExt cx="2129345" cy="810913"/>
              </a:xfrm>
            </p:grpSpPr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xmlns="" id="{F6AFC8AD-CC67-48D6-8D0B-B7EF045BADF0}"/>
                    </a:ext>
                  </a:extLst>
                </p:cNvPr>
                <p:cNvSpPr txBox="1"/>
                <p:nvPr/>
              </p:nvSpPr>
              <p:spPr>
                <a:xfrm>
                  <a:off x="890114" y="924336"/>
                  <a:ext cx="828768" cy="2708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rambled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xmlns="" id="{F9DE7D62-6D3A-44B6-A0CA-47759DC8896F}"/>
                    </a:ext>
                  </a:extLst>
                </p:cNvPr>
                <p:cNvSpPr txBox="1"/>
                <p:nvPr/>
              </p:nvSpPr>
              <p:spPr>
                <a:xfrm>
                  <a:off x="1809333" y="924336"/>
                  <a:ext cx="442967" cy="4401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g5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직사각형 107">
                  <a:extLst>
                    <a:ext uri="{FF2B5EF4-FFF2-40B4-BE49-F238E27FC236}">
                      <a16:creationId xmlns:a16="http://schemas.microsoft.com/office/drawing/2014/main" xmlns="" id="{9533317B-ACFD-4647-8E3E-86940A836FC2}"/>
                    </a:ext>
                  </a:extLst>
                </p:cNvPr>
                <p:cNvSpPr/>
                <p:nvPr/>
              </p:nvSpPr>
              <p:spPr>
                <a:xfrm>
                  <a:off x="832504" y="1193623"/>
                  <a:ext cx="1341635" cy="270843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dist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+++</a:t>
                  </a:r>
                </a:p>
              </p:txBody>
            </p:sp>
            <p:sp>
              <p:nvSpPr>
                <p:cNvPr id="109" name="직사각형 108">
                  <a:extLst>
                    <a:ext uri="{FF2B5EF4-FFF2-40B4-BE49-F238E27FC236}">
                      <a16:creationId xmlns:a16="http://schemas.microsoft.com/office/drawing/2014/main" xmlns="" id="{7BF37474-B307-4381-BA98-A111BF8BFE27}"/>
                    </a:ext>
                  </a:extLst>
                </p:cNvPr>
                <p:cNvSpPr/>
                <p:nvPr/>
              </p:nvSpPr>
              <p:spPr>
                <a:xfrm>
                  <a:off x="832504" y="1465787"/>
                  <a:ext cx="1341635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dist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-++</a:t>
                  </a:r>
                </a:p>
              </p:txBody>
            </p:sp>
            <p:sp>
              <p:nvSpPr>
                <p:cNvPr id="110" name="직사각형 109">
                  <a:extLst>
                    <a:ext uri="{FF2B5EF4-FFF2-40B4-BE49-F238E27FC236}">
                      <a16:creationId xmlns:a16="http://schemas.microsoft.com/office/drawing/2014/main" xmlns="" id="{018BE8E3-7B6F-4959-BCBE-D03160BE3F6C}"/>
                    </a:ext>
                  </a:extLst>
                </p:cNvPr>
                <p:cNvSpPr/>
                <p:nvPr/>
              </p:nvSpPr>
              <p:spPr>
                <a:xfrm>
                  <a:off x="122955" y="1464406"/>
                  <a:ext cx="689612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ko-KR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elasolv</a:t>
                  </a:r>
                  <a:endPara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직사각형 110">
                  <a:extLst>
                    <a:ext uri="{FF2B5EF4-FFF2-40B4-BE49-F238E27FC236}">
                      <a16:creationId xmlns:a16="http://schemas.microsoft.com/office/drawing/2014/main" xmlns="" id="{36BF70B8-E9EC-4A83-80B4-E90DFD225CF8}"/>
                    </a:ext>
                  </a:extLst>
                </p:cNvPr>
                <p:cNvSpPr/>
                <p:nvPr/>
              </p:nvSpPr>
              <p:spPr>
                <a:xfrm>
                  <a:off x="225547" y="1213122"/>
                  <a:ext cx="587020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l-GR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-</a:t>
                  </a:r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SH</a:t>
                  </a:r>
                </a:p>
              </p:txBody>
            </p:sp>
            <p:sp>
              <p:nvSpPr>
                <p:cNvPr id="112" name="직사각형 111">
                  <a:extLst>
                    <a:ext uri="{FF2B5EF4-FFF2-40B4-BE49-F238E27FC236}">
                      <a16:creationId xmlns:a16="http://schemas.microsoft.com/office/drawing/2014/main" xmlns="" id="{7B34FDC5-0C42-4774-94AD-F7B7CD89E25F}"/>
                    </a:ext>
                  </a:extLst>
                </p:cNvPr>
                <p:cNvSpPr/>
                <p:nvPr/>
              </p:nvSpPr>
              <p:spPr>
                <a:xfrm>
                  <a:off x="244082" y="985749"/>
                  <a:ext cx="548548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RNA</a:t>
                  </a:r>
                </a:p>
              </p:txBody>
            </p:sp>
            <p:cxnSp>
              <p:nvCxnSpPr>
                <p:cNvPr id="113" name="직선 연결선 112">
                  <a:extLst>
                    <a:ext uri="{FF2B5EF4-FFF2-40B4-BE49-F238E27FC236}">
                      <a16:creationId xmlns:a16="http://schemas.microsoft.com/office/drawing/2014/main" xmlns="" id="{64464DC6-3744-4AEA-A44F-91715BB89425}"/>
                    </a:ext>
                  </a:extLst>
                </p:cNvPr>
                <p:cNvCxnSpPr/>
                <p:nvPr/>
              </p:nvCxnSpPr>
              <p:spPr>
                <a:xfrm>
                  <a:off x="901637" y="1193623"/>
                  <a:ext cx="81724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직선 연결선 113">
                  <a:extLst>
                    <a:ext uri="{FF2B5EF4-FFF2-40B4-BE49-F238E27FC236}">
                      <a16:creationId xmlns:a16="http://schemas.microsoft.com/office/drawing/2014/main" xmlns="" id="{85A2A66A-89A9-4680-853D-96D4D6D626C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98074" y="1193623"/>
                  <a:ext cx="275047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xmlns="" id="{1ED926B2-08C5-4963-9944-9424879A1B70}"/>
                </a:ext>
              </a:extLst>
            </p:cNvPr>
            <p:cNvSpPr txBox="1"/>
            <p:nvPr/>
          </p:nvSpPr>
          <p:spPr>
            <a:xfrm>
              <a:off x="6314181" y="120889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그룹 39">
            <a:extLst>
              <a:ext uri="{FF2B5EF4-FFF2-40B4-BE49-F238E27FC236}">
                <a16:creationId xmlns:a16="http://schemas.microsoft.com/office/drawing/2014/main" xmlns="" id="{D2081B79-5713-48BD-97AF-EBBCE1E59539}"/>
              </a:ext>
            </a:extLst>
          </p:cNvPr>
          <p:cNvGrpSpPr/>
          <p:nvPr/>
        </p:nvGrpSpPr>
        <p:grpSpPr>
          <a:xfrm>
            <a:off x="8942803" y="1580342"/>
            <a:ext cx="2963541" cy="3653912"/>
            <a:chOff x="9233037" y="1208899"/>
            <a:chExt cx="2963541" cy="3653912"/>
          </a:xfrm>
        </p:grpSpPr>
        <p:grpSp>
          <p:nvGrpSpPr>
            <p:cNvPr id="33" name="그룹 32">
              <a:extLst>
                <a:ext uri="{FF2B5EF4-FFF2-40B4-BE49-F238E27FC236}">
                  <a16:creationId xmlns:a16="http://schemas.microsoft.com/office/drawing/2014/main" xmlns="" id="{ECE210D9-F267-46A3-9837-D00301ECD1FB}"/>
                </a:ext>
              </a:extLst>
            </p:cNvPr>
            <p:cNvGrpSpPr/>
            <p:nvPr/>
          </p:nvGrpSpPr>
          <p:grpSpPr>
            <a:xfrm>
              <a:off x="9330079" y="1585430"/>
              <a:ext cx="2866499" cy="3277381"/>
              <a:chOff x="9330079" y="1757369"/>
              <a:chExt cx="2866499" cy="3277381"/>
            </a:xfrm>
          </p:grpSpPr>
          <p:pic>
            <p:nvPicPr>
              <p:cNvPr id="12" name="그림 11">
                <a:extLst>
                  <a:ext uri="{FF2B5EF4-FFF2-40B4-BE49-F238E27FC236}">
                    <a16:creationId xmlns:a16="http://schemas.microsoft.com/office/drawing/2014/main" xmlns="" id="{7B759F3E-4B03-4991-AFCB-8606BE3ED2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972205" y="2617947"/>
                <a:ext cx="1584400" cy="241680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xmlns="" id="{9911FC0F-2F52-4C13-B2D3-DED6C99E6DB1}"/>
                  </a:ext>
                </a:extLst>
              </p:cNvPr>
              <p:cNvSpPr txBox="1"/>
              <p:nvPr/>
            </p:nvSpPr>
            <p:spPr>
              <a:xfrm>
                <a:off x="11567469" y="4098941"/>
                <a:ext cx="6291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직사각형 75">
                <a:extLst>
                  <a:ext uri="{FF2B5EF4-FFF2-40B4-BE49-F238E27FC236}">
                    <a16:creationId xmlns:a16="http://schemas.microsoft.com/office/drawing/2014/main" xmlns="" id="{BC9E1F6E-F179-4D97-A44C-FD9C3E9D3AF1}"/>
                  </a:ext>
                </a:extLst>
              </p:cNvPr>
              <p:cNvSpPr/>
              <p:nvPr/>
            </p:nvSpPr>
            <p:spPr>
              <a:xfrm>
                <a:off x="9972205" y="4011907"/>
                <a:ext cx="1595264" cy="411158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n w="57150">
                    <a:solidFill>
                      <a:schemeClr val="tx1"/>
                    </a:solidFill>
                  </a:ln>
                </a:endParaRPr>
              </a:p>
            </p:txBody>
          </p:sp>
          <p:grpSp>
            <p:nvGrpSpPr>
              <p:cNvPr id="115" name="그룹 114">
                <a:extLst>
                  <a:ext uri="{FF2B5EF4-FFF2-40B4-BE49-F238E27FC236}">
                    <a16:creationId xmlns:a16="http://schemas.microsoft.com/office/drawing/2014/main" xmlns="" id="{32182AC2-3F78-4A58-91D1-D2A835FDFF26}"/>
                  </a:ext>
                </a:extLst>
              </p:cNvPr>
              <p:cNvGrpSpPr/>
              <p:nvPr/>
            </p:nvGrpSpPr>
            <p:grpSpPr>
              <a:xfrm>
                <a:off x="9330079" y="1757369"/>
                <a:ext cx="2129345" cy="810913"/>
                <a:chOff x="122955" y="924336"/>
                <a:chExt cx="2129345" cy="810913"/>
              </a:xfrm>
            </p:grpSpPr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xmlns="" id="{5F89CAA3-00FA-49A2-999B-598EF0F03B4B}"/>
                    </a:ext>
                  </a:extLst>
                </p:cNvPr>
                <p:cNvSpPr txBox="1"/>
                <p:nvPr/>
              </p:nvSpPr>
              <p:spPr>
                <a:xfrm>
                  <a:off x="890114" y="924336"/>
                  <a:ext cx="828768" cy="2708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rambled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xmlns="" id="{48B784F1-A235-4118-9738-684C0980DD68}"/>
                    </a:ext>
                  </a:extLst>
                </p:cNvPr>
                <p:cNvSpPr txBox="1"/>
                <p:nvPr/>
              </p:nvSpPr>
              <p:spPr>
                <a:xfrm>
                  <a:off x="1809333" y="924336"/>
                  <a:ext cx="442967" cy="4401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g5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직사각형 117">
                  <a:extLst>
                    <a:ext uri="{FF2B5EF4-FFF2-40B4-BE49-F238E27FC236}">
                      <a16:creationId xmlns:a16="http://schemas.microsoft.com/office/drawing/2014/main" xmlns="" id="{FD52E3EE-E1A4-4B73-B5D3-C860BD700FE7}"/>
                    </a:ext>
                  </a:extLst>
                </p:cNvPr>
                <p:cNvSpPr/>
                <p:nvPr/>
              </p:nvSpPr>
              <p:spPr>
                <a:xfrm>
                  <a:off x="832504" y="1193623"/>
                  <a:ext cx="1341635" cy="270843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dist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+++</a:t>
                  </a:r>
                </a:p>
              </p:txBody>
            </p:sp>
            <p:sp>
              <p:nvSpPr>
                <p:cNvPr id="119" name="직사각형 118">
                  <a:extLst>
                    <a:ext uri="{FF2B5EF4-FFF2-40B4-BE49-F238E27FC236}">
                      <a16:creationId xmlns:a16="http://schemas.microsoft.com/office/drawing/2014/main" xmlns="" id="{C7E27491-FE43-452E-92C7-CA2966CD945E}"/>
                    </a:ext>
                  </a:extLst>
                </p:cNvPr>
                <p:cNvSpPr/>
                <p:nvPr/>
              </p:nvSpPr>
              <p:spPr>
                <a:xfrm>
                  <a:off x="832504" y="1465787"/>
                  <a:ext cx="1341635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dist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-++</a:t>
                  </a:r>
                </a:p>
              </p:txBody>
            </p:sp>
            <p:sp>
              <p:nvSpPr>
                <p:cNvPr id="120" name="직사각형 119">
                  <a:extLst>
                    <a:ext uri="{FF2B5EF4-FFF2-40B4-BE49-F238E27FC236}">
                      <a16:creationId xmlns:a16="http://schemas.microsoft.com/office/drawing/2014/main" xmlns="" id="{A7AF671C-7A28-4C55-BBD2-7EABBBE002D5}"/>
                    </a:ext>
                  </a:extLst>
                </p:cNvPr>
                <p:cNvSpPr/>
                <p:nvPr/>
              </p:nvSpPr>
              <p:spPr>
                <a:xfrm>
                  <a:off x="122955" y="1464406"/>
                  <a:ext cx="689612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ko-KR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elasolv</a:t>
                  </a:r>
                  <a:endPara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직사각형 120">
                  <a:extLst>
                    <a:ext uri="{FF2B5EF4-FFF2-40B4-BE49-F238E27FC236}">
                      <a16:creationId xmlns:a16="http://schemas.microsoft.com/office/drawing/2014/main" xmlns="" id="{8D060193-2EB1-442B-9B18-1B369BB3B073}"/>
                    </a:ext>
                  </a:extLst>
                </p:cNvPr>
                <p:cNvSpPr/>
                <p:nvPr/>
              </p:nvSpPr>
              <p:spPr>
                <a:xfrm>
                  <a:off x="225547" y="1213122"/>
                  <a:ext cx="587020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l-GR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-</a:t>
                  </a:r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SH</a:t>
                  </a:r>
                </a:p>
              </p:txBody>
            </p:sp>
            <p:sp>
              <p:nvSpPr>
                <p:cNvPr id="122" name="직사각형 121">
                  <a:extLst>
                    <a:ext uri="{FF2B5EF4-FFF2-40B4-BE49-F238E27FC236}">
                      <a16:creationId xmlns:a16="http://schemas.microsoft.com/office/drawing/2014/main" xmlns="" id="{81F18E68-906B-429B-AED0-4C9B88185321}"/>
                    </a:ext>
                  </a:extLst>
                </p:cNvPr>
                <p:cNvSpPr/>
                <p:nvPr/>
              </p:nvSpPr>
              <p:spPr>
                <a:xfrm>
                  <a:off x="244082" y="985749"/>
                  <a:ext cx="548548" cy="2708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RNA</a:t>
                  </a:r>
                </a:p>
              </p:txBody>
            </p:sp>
            <p:cxnSp>
              <p:nvCxnSpPr>
                <p:cNvPr id="123" name="직선 연결선 122">
                  <a:extLst>
                    <a:ext uri="{FF2B5EF4-FFF2-40B4-BE49-F238E27FC236}">
                      <a16:creationId xmlns:a16="http://schemas.microsoft.com/office/drawing/2014/main" xmlns="" id="{9DDEECB3-788E-4353-B492-15DE6887BB5D}"/>
                    </a:ext>
                  </a:extLst>
                </p:cNvPr>
                <p:cNvCxnSpPr/>
                <p:nvPr/>
              </p:nvCxnSpPr>
              <p:spPr>
                <a:xfrm>
                  <a:off x="901637" y="1193623"/>
                  <a:ext cx="81724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직선 연결선 123">
                  <a:extLst>
                    <a:ext uri="{FF2B5EF4-FFF2-40B4-BE49-F238E27FC236}">
                      <a16:creationId xmlns:a16="http://schemas.microsoft.com/office/drawing/2014/main" xmlns="" id="{0D413E98-BFFC-45F0-B7F7-2E9FF8DD560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98074" y="1193623"/>
                  <a:ext cx="275047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xmlns="" id="{B94045B3-3D87-4511-A335-D67D6CA99456}"/>
                </a:ext>
              </a:extLst>
            </p:cNvPr>
            <p:cNvSpPr txBox="1"/>
            <p:nvPr/>
          </p:nvSpPr>
          <p:spPr>
            <a:xfrm>
              <a:off x="9233037" y="120889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80242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Custom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oosin Jo</dc:creator>
  <cp:lastModifiedBy>PG3646</cp:lastModifiedBy>
  <cp:revision>2</cp:revision>
  <dcterms:created xsi:type="dcterms:W3CDTF">2020-08-12T09:53:11Z</dcterms:created>
  <dcterms:modified xsi:type="dcterms:W3CDTF">2020-09-04T14:10:57Z</dcterms:modified>
</cp:coreProperties>
</file>